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3"/>
  </p:notesMasterIdLst>
  <p:sldIdLst>
    <p:sldId id="305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uki Sasai" initials="HS" lastIdx="7" clrIdx="0">
    <p:extLst>
      <p:ext uri="{19B8F6BF-5375-455C-9EA6-DF929625EA0E}">
        <p15:presenceInfo xmlns:p15="http://schemas.microsoft.com/office/powerpoint/2012/main" userId="Hiroyuki Sasai" providerId="None"/>
      </p:ext>
    </p:extLst>
  </p:cmAuthor>
  <p:cmAuthor id="2" name="Nemoto Miyuki" initials="NM" lastIdx="13" clrIdx="1">
    <p:extLst>
      <p:ext uri="{19B8F6BF-5375-455C-9EA6-DF929625EA0E}">
        <p15:presenceInfo xmlns:p15="http://schemas.microsoft.com/office/powerpoint/2012/main" userId="457862ac872fa326" providerId="Windows Live"/>
      </p:ext>
    </p:extLst>
  </p:cmAuthor>
  <p:cmAuthor id="3" name="Hiroyuki Sasai" initials="HS [2]" lastIdx="6" clrIdx="2">
    <p:extLst>
      <p:ext uri="{19B8F6BF-5375-455C-9EA6-DF929625EA0E}">
        <p15:presenceInfo xmlns:p15="http://schemas.microsoft.com/office/powerpoint/2012/main" userId="2da4cb180539edf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49452"/>
    <a:srgbClr val="BCB6BF"/>
    <a:srgbClr val="949B88"/>
    <a:srgbClr val="856F5C"/>
    <a:srgbClr val="FEF2E8"/>
    <a:srgbClr val="38D2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345" autoAdjust="0"/>
    <p:restoredTop sz="93343" autoAdjust="0"/>
  </p:normalViewPr>
  <p:slideViewPr>
    <p:cSldViewPr snapToGrid="0" showGuides="1">
      <p:cViewPr varScale="1">
        <p:scale>
          <a:sx n="96" d="100"/>
          <a:sy n="96" d="100"/>
        </p:scale>
        <p:origin x="980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2C61E9-A6EC-4EC5-B121-5B0598B7AF4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35B339-8AC6-4E96-BDBB-771F82D23A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587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05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32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98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063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8626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525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349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713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27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033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97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2B5DD-70FD-4C09-88A5-9F8AC1E50316}" type="datetimeFigureOut">
              <a:rPr kumimoji="1" lang="ja-JP" altLang="en-US" smtClean="0"/>
              <a:t>2020/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1A31B-D4B4-4407-8D11-18397316A0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273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5A7788-7310-45B0-92FA-87CCB6953D10}"/>
              </a:ext>
            </a:extLst>
          </p:cNvPr>
          <p:cNvSpPr txBox="1"/>
          <p:nvPr/>
        </p:nvSpPr>
        <p:spPr>
          <a:xfrm>
            <a:off x="1328129" y="4782327"/>
            <a:ext cx="566328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. No circle was described</a:t>
            </a:r>
          </a:p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. The hands were not described in the correct position</a:t>
            </a:r>
            <a:endParaRPr lang="ja-JP" alt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. The only one hand was described</a:t>
            </a:r>
          </a:p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. The same two numbers (6) were  written</a:t>
            </a:r>
          </a:p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. The position of the numbers were incorrect</a:t>
            </a:r>
            <a:r>
              <a:rPr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. The center of the clock was not placed in the right position </a:t>
            </a:r>
            <a:endParaRPr kumimoji="1" lang="ja-JP" alt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69ED1671-A83D-45D0-91A7-4280BD519B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8129" y="470384"/>
            <a:ext cx="6487741" cy="422657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E6C8F3B-CDCC-40EE-9E63-C63871A628D1}"/>
              </a:ext>
            </a:extLst>
          </p:cNvPr>
          <p:cNvSpPr txBox="1"/>
          <p:nvPr/>
        </p:nvSpPr>
        <p:spPr>
          <a:xfrm>
            <a:off x="2210730" y="6412631"/>
            <a:ext cx="4722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 2. Examples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of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rrors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in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lock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rawing</a:t>
            </a:r>
            <a:r>
              <a:rPr kumimoji="1" lang="ja-JP" alt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est.</a:t>
            </a:r>
            <a:endParaRPr kumimoji="1" lang="ja-JP" alt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2704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83</TotalTime>
  <Words>70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EMOTO Miyuki</dc:creator>
  <cp:lastModifiedBy>Nemoto Miyuki</cp:lastModifiedBy>
  <cp:revision>329</cp:revision>
  <cp:lastPrinted>2018-03-06T23:09:17Z</cp:lastPrinted>
  <dcterms:created xsi:type="dcterms:W3CDTF">2016-06-20T02:37:35Z</dcterms:created>
  <dcterms:modified xsi:type="dcterms:W3CDTF">2020-02-25T15:40:33Z</dcterms:modified>
</cp:coreProperties>
</file>